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119813" cy="809942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DF924-9A17-48C3-9E05-2E1B4437469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5508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6360" y="4682880"/>
            <a:ext cx="5508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03A1B-042F-45DD-8D01-4F2EFADE19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29120" y="189072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6360" y="468288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29120" y="468288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2F600B-A8A5-4DBD-81DD-A6CD757B2B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1773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69000" y="1890720"/>
            <a:ext cx="1773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32000" y="1890720"/>
            <a:ext cx="1773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6360" y="4682880"/>
            <a:ext cx="1773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69000" y="4682880"/>
            <a:ext cx="1773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32000" y="4682880"/>
            <a:ext cx="1773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A94894-A710-4604-A4A9-AF15A4E1A2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6360" y="1890720"/>
            <a:ext cx="5508720" cy="5345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91EDB1-BC53-415D-B06C-6AF60D0E39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5508720" cy="534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D8D4FF-85DD-4714-821D-46787B1A5F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2688120" cy="534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29120" y="1890720"/>
            <a:ext cx="2688120" cy="534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AF89EC-2FAC-4071-86D8-8DD5D2E8FA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7A96E-720F-417C-80D1-4B51DCF09A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6360" y="324000"/>
            <a:ext cx="5508720" cy="6262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50712-0FA3-49CD-8C88-058E7C0802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29120" y="1890720"/>
            <a:ext cx="2688120" cy="534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6360" y="468288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ED74A-832C-4884-8F21-1028BCC02C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2688120" cy="534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29120" y="189072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29120" y="468288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E55EB-2077-4EF9-B94F-C7B51B6D6C3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6360" y="189072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29120" y="1890720"/>
            <a:ext cx="26881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6360" y="4682880"/>
            <a:ext cx="5508720" cy="254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63FD3C-5E3F-4F46-B5FA-CA23F4E65A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6360" y="324000"/>
            <a:ext cx="5508720" cy="135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6360" y="1890720"/>
            <a:ext cx="5508720" cy="5345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06000" y="7508520"/>
            <a:ext cx="1428840" cy="43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90880" y="7508520"/>
            <a:ext cx="1939680" cy="43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385880" y="7508520"/>
            <a:ext cx="1428840" cy="430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61AC63-6A63-4D33-B93A-09E1CF9A0C2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24000" y="306360"/>
          <a:ext cx="2520720" cy="2316240"/>
        </p:xfrm>
        <a:graphic>
          <a:graphicData uri="http://schemas.openxmlformats.org/drawingml/2006/table">
            <a:tbl>
              <a:tblPr/>
              <a:tblGrid>
                <a:gridCol w="630000"/>
                <a:gridCol w="630360"/>
                <a:gridCol w="630360"/>
                <a:gridCol w="630000"/>
              </a:tblGrid>
              <a:tr h="28908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52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[C&gt;A]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872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[C&gt;G]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908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[C&gt;T]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520">
                <a:tc gridSpan="4"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…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8872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[T&gt;A]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52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[T&gt;C]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908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[T&gt;G]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cxnSp>
        <p:nvCxnSpPr>
          <p:cNvPr id="42" name="Straight Arrow Connector 4"/>
          <p:cNvCxnSpPr/>
          <p:nvPr/>
        </p:nvCxnSpPr>
        <p:spPr>
          <a:xfrm>
            <a:off x="1819440" y="2668320"/>
            <a:ext cx="234000" cy="2466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43" name="TextBox 6"/>
          <p:cNvSpPr/>
          <p:nvPr/>
        </p:nvSpPr>
        <p:spPr>
          <a:xfrm>
            <a:off x="2124000" y="2754360"/>
            <a:ext cx="2376720" cy="34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27080" rIns="127080" tIns="63360" bIns="633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Combine the two matric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4" name=""/>
          <p:cNvGraphicFramePr/>
          <p:nvPr/>
        </p:nvGraphicFramePr>
        <p:xfrm>
          <a:off x="3243240" y="306360"/>
          <a:ext cx="2554200" cy="2316240"/>
        </p:xfrm>
        <a:graphic>
          <a:graphicData uri="http://schemas.openxmlformats.org/drawingml/2006/table">
            <a:tbl>
              <a:tblPr/>
              <a:tblGrid>
                <a:gridCol w="638280"/>
                <a:gridCol w="637920"/>
                <a:gridCol w="638280"/>
                <a:gridCol w="639720"/>
              </a:tblGrid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[C&gt;A]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[C&gt;G]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[C&gt;T]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160">
                <a:tc gridSpan="4"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…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[T&gt;A]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[T&gt;C]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[T&gt;G]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828720" y="3102120"/>
          <a:ext cx="4464000" cy="2315880"/>
        </p:xfrm>
        <a:graphic>
          <a:graphicData uri="http://schemas.openxmlformats.org/drawingml/2006/table">
            <a:tbl>
              <a:tblPr/>
              <a:tblGrid>
                <a:gridCol w="638280"/>
                <a:gridCol w="636480"/>
                <a:gridCol w="638280"/>
                <a:gridCol w="637920"/>
                <a:gridCol w="638280"/>
                <a:gridCol w="636480"/>
                <a:gridCol w="638280"/>
              </a:tblGrid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ample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[C&gt;A]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[C&gt;G]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[C&gt;T]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160">
                <a:tc gridSpan="7"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…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[T&gt;A]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[T&gt;C]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0160"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636480"/>
                          <a:tab algn="l" pos="1273320"/>
                          <a:tab algn="l" pos="1909800"/>
                          <a:tab algn="l" pos="2546280"/>
                          <a:tab algn="l" pos="3182760"/>
                          <a:tab algn="l" pos="3819600"/>
                          <a:tab algn="l" pos="4456080"/>
                          <a:tab algn="l" pos="5092560"/>
                          <a:tab algn="l" pos="5729400"/>
                          <a:tab algn="l" pos="6365880"/>
                          <a:tab algn="l" pos="7002360"/>
                          <a:tab algn="l" pos="7639200"/>
                          <a:tab algn="l" pos="8275680"/>
                          <a:tab algn="l" pos="8912160"/>
                          <a:tab algn="l" pos="9548640"/>
                          <a:tab algn="l" pos="10185480"/>
                          <a:tab algn="l" pos="1082196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[T&gt;G]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68760" bIns="6876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0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cxnSp>
        <p:nvCxnSpPr>
          <p:cNvPr id="46" name="Straight Arrow Connector 2"/>
          <p:cNvCxnSpPr/>
          <p:nvPr/>
        </p:nvCxnSpPr>
        <p:spPr>
          <a:xfrm>
            <a:off x="3063600" y="5491080"/>
            <a:ext cx="1080" cy="2880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47" name="TextBox 12"/>
          <p:cNvSpPr/>
          <p:nvPr/>
        </p:nvSpPr>
        <p:spPr>
          <a:xfrm>
            <a:off x="1314360" y="5759280"/>
            <a:ext cx="3498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Calibri"/>
              </a:rPr>
              <a:t>Run MutSpec-NMF with the combined matri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8"/>
          <p:cNvSpPr/>
          <p:nvPr/>
        </p:nvSpPr>
        <p:spPr>
          <a:xfrm>
            <a:off x="650880" y="17640"/>
            <a:ext cx="18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Matrix from analysis 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3"/>
          <p:cNvSpPr/>
          <p:nvPr/>
        </p:nvSpPr>
        <p:spPr>
          <a:xfrm>
            <a:off x="3637080" y="17640"/>
            <a:ext cx="187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Matrix from analysis 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2" descr=""/>
          <p:cNvPicPr/>
          <p:nvPr/>
        </p:nvPicPr>
        <p:blipFill>
          <a:blip r:embed="rId1"/>
          <a:stretch/>
        </p:blipFill>
        <p:spPr>
          <a:xfrm>
            <a:off x="1044720" y="6067440"/>
            <a:ext cx="3997080" cy="1994040"/>
          </a:xfrm>
          <a:prstGeom prst="rect">
            <a:avLst/>
          </a:prstGeom>
          <a:ln w="0">
            <a:noFill/>
          </a:ln>
        </p:spPr>
      </p:pic>
      <p:cxnSp>
        <p:nvCxnSpPr>
          <p:cNvPr id="51" name="Straight Arrow Connector 17"/>
          <p:cNvCxnSpPr/>
          <p:nvPr/>
        </p:nvCxnSpPr>
        <p:spPr>
          <a:xfrm flipH="1">
            <a:off x="4322160" y="2682720"/>
            <a:ext cx="200520" cy="2325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29T07:33:28Z</dcterms:created>
  <dc:creator>Windows User</dc:creator>
  <dc:description/>
  <dc:language>en-US</dc:language>
  <cp:lastModifiedBy>magali olivier</cp:lastModifiedBy>
  <dcterms:modified xsi:type="dcterms:W3CDTF">2015-08-26T15:08:29Z</dcterms:modified>
  <cp:revision>11</cp:revision>
  <dc:subject/>
  <dc:title>PowerPoint Presentation</dc:title>
</cp:coreProperties>
</file>